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1B3DA-C759-48D8-A614-F8D4ED364A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41CF9-F016-4CEF-A4E2-F63924035D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CC4F98-81D9-41DA-9F68-FDB5AB5ED4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56879-8B82-4B8A-B2A4-785758308F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61E0B-EC2B-451A-A515-8CC99F8945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48C50-E69C-4E9F-89CA-58FCF26506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88DA0-3549-4678-BB59-0B966DA1C8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3B957-0D19-4FC0-969D-3A49B11032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23E617-6628-4C51-8F0B-9CB950F5B7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32938-D082-4A36-86BE-5CEAEAD456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4C9DB7-8D53-4CAD-BBE3-35B85B6075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CCA31-9FF9-47BA-8DAE-68EA2913DB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EA1694-1BC9-48CC-A65D-BF91803E5CC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Egyenes összekötő 45"/>
          <p:cNvSpPr/>
          <p:nvPr/>
        </p:nvSpPr>
        <p:spPr>
          <a:xfrm>
            <a:off x="785160" y="928800"/>
            <a:ext cx="538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Kép 1" descr="070530_stk_b121_b18_b111_01.tif"/>
          <p:cNvPicPr/>
          <p:nvPr/>
        </p:nvPicPr>
        <p:blipFill>
          <a:blip r:embed="rId1">
            <a:lum bright="-6000"/>
          </a:blip>
          <a:srcRect l="6804" t="0" r="70115" b="48616"/>
          <a:stretch/>
        </p:blipFill>
        <p:spPr>
          <a:xfrm>
            <a:off x="2643120" y="1785960"/>
            <a:ext cx="1582920" cy="2643120"/>
          </a:xfrm>
          <a:prstGeom prst="rect">
            <a:avLst/>
          </a:prstGeom>
          <a:ln w="9360">
            <a:solidFill>
              <a:srgbClr val="4f81bd"/>
            </a:solidFill>
            <a:miter/>
          </a:ln>
        </p:spPr>
      </p:pic>
      <p:sp>
        <p:nvSpPr>
          <p:cNvPr id="43" name="Egyenes összekötő 61"/>
          <p:cNvSpPr/>
          <p:nvPr/>
        </p:nvSpPr>
        <p:spPr>
          <a:xfrm>
            <a:off x="2421000" y="3336840"/>
            <a:ext cx="28584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Egyenes összekötő 62"/>
          <p:cNvSpPr/>
          <p:nvPr/>
        </p:nvSpPr>
        <p:spPr>
          <a:xfrm>
            <a:off x="2421000" y="3478320"/>
            <a:ext cx="28584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Egyenes összekötő 63"/>
          <p:cNvSpPr/>
          <p:nvPr/>
        </p:nvSpPr>
        <p:spPr>
          <a:xfrm>
            <a:off x="2421000" y="3641760"/>
            <a:ext cx="28584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Egyenes összekötő 64"/>
          <p:cNvSpPr/>
          <p:nvPr/>
        </p:nvSpPr>
        <p:spPr>
          <a:xfrm>
            <a:off x="2421000" y="3897360"/>
            <a:ext cx="28584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Egyenes összekötő 65"/>
          <p:cNvSpPr/>
          <p:nvPr/>
        </p:nvSpPr>
        <p:spPr>
          <a:xfrm>
            <a:off x="2421000" y="3170160"/>
            <a:ext cx="28584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Egyenes összekötő 66"/>
          <p:cNvSpPr/>
          <p:nvPr/>
        </p:nvSpPr>
        <p:spPr>
          <a:xfrm>
            <a:off x="2421000" y="3060720"/>
            <a:ext cx="28584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Egyenes összekötő 67"/>
          <p:cNvSpPr/>
          <p:nvPr/>
        </p:nvSpPr>
        <p:spPr>
          <a:xfrm>
            <a:off x="2421000" y="2906640"/>
            <a:ext cx="28584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Egyenes összekötő 68"/>
          <p:cNvSpPr/>
          <p:nvPr/>
        </p:nvSpPr>
        <p:spPr>
          <a:xfrm>
            <a:off x="2421000" y="2673360"/>
            <a:ext cx="28584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zövegdoboz 15"/>
          <p:cNvSpPr/>
          <p:nvPr/>
        </p:nvSpPr>
        <p:spPr>
          <a:xfrm>
            <a:off x="1897200" y="250812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10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zövegdoboz 16"/>
          <p:cNvSpPr/>
          <p:nvPr/>
        </p:nvSpPr>
        <p:spPr>
          <a:xfrm>
            <a:off x="1897200" y="274464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5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zövegdoboz 17"/>
          <p:cNvSpPr/>
          <p:nvPr/>
        </p:nvSpPr>
        <p:spPr>
          <a:xfrm>
            <a:off x="1897200" y="289872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2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zövegdoboz 18"/>
          <p:cNvSpPr/>
          <p:nvPr/>
        </p:nvSpPr>
        <p:spPr>
          <a:xfrm>
            <a:off x="1754280" y="3040200"/>
            <a:ext cx="70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1.5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zövegdoboz 19"/>
          <p:cNvSpPr/>
          <p:nvPr/>
        </p:nvSpPr>
        <p:spPr>
          <a:xfrm>
            <a:off x="1897200" y="317340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1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zövegdoboz 20"/>
          <p:cNvSpPr/>
          <p:nvPr/>
        </p:nvSpPr>
        <p:spPr>
          <a:xfrm>
            <a:off x="1682640" y="335124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0.75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zövegdoboz 21"/>
          <p:cNvSpPr/>
          <p:nvPr/>
        </p:nvSpPr>
        <p:spPr>
          <a:xfrm>
            <a:off x="1754280" y="3513240"/>
            <a:ext cx="70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0.50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Szövegdoboz 22"/>
          <p:cNvSpPr/>
          <p:nvPr/>
        </p:nvSpPr>
        <p:spPr>
          <a:xfrm>
            <a:off x="1682640" y="374328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0.25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églalap 9"/>
          <p:cNvSpPr/>
          <p:nvPr/>
        </p:nvSpPr>
        <p:spPr>
          <a:xfrm rot="16200000">
            <a:off x="3715920" y="2029320"/>
            <a:ext cx="56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600" spc="-1" strike="noStrike">
                <a:solidFill>
                  <a:srgbClr val="000000"/>
                </a:solidFill>
                <a:latin typeface="Arial"/>
              </a:rPr>
              <a:t>Del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églalap 9"/>
          <p:cNvSpPr/>
          <p:nvPr/>
        </p:nvSpPr>
        <p:spPr>
          <a:xfrm rot="16200000">
            <a:off x="2928240" y="2003400"/>
            <a:ext cx="61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600" spc="-1" strike="noStrike">
                <a:solidFill>
                  <a:srgbClr val="000000"/>
                </a:solidFill>
                <a:latin typeface="Arial"/>
              </a:rPr>
              <a:t>Del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églalap 9"/>
          <p:cNvSpPr/>
          <p:nvPr/>
        </p:nvSpPr>
        <p:spPr>
          <a:xfrm rot="16200000">
            <a:off x="3326400" y="2003400"/>
            <a:ext cx="61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600" spc="-1" strike="noStrike">
                <a:solidFill>
                  <a:srgbClr val="000000"/>
                </a:solidFill>
                <a:latin typeface="Arial"/>
              </a:rPr>
              <a:t>Del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églalap 9"/>
          <p:cNvSpPr/>
          <p:nvPr/>
        </p:nvSpPr>
        <p:spPr>
          <a:xfrm>
            <a:off x="2608560" y="2146320"/>
            <a:ext cx="54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600" spc="-1" strike="noStrike">
                <a:solidFill>
                  <a:srgbClr val="000000"/>
                </a:solidFill>
                <a:latin typeface="Arial"/>
              </a:rPr>
              <a:t>MW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zövegdoboz 16"/>
          <p:cNvSpPr/>
          <p:nvPr/>
        </p:nvSpPr>
        <p:spPr>
          <a:xfrm>
            <a:off x="285840" y="4519440"/>
            <a:ext cx="6286320" cy="193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1: XL-PCR analysis of two samples carrying the genomic deletion of exons 2-3 of the STK11 gen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The results of the PCR amplification using primers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(marked by red arrowheads on the schematic drawing of the gene) in intron 1 (5'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TGCCCTTTCCTGTCACTTC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-3') and intron 3 (5'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GCAGGCCCAGCAAAGAT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-3') in deletion carriers (Del+; patients  4688 and 4689) and in a non-carrier (Del-) sample. The Expand Long Template PCR system (Roche) with Buffer 3 was used for amplification with the cycling conditions 93°C for 3 min, followed by 28 cycles of 93°C  for 10 sec, 61°C for 30s and 68°C for 8 min and completed with a final extension step of 68°C for 20 min. Although solely a 8332 bp band was expected in the normal control sample, amplification was successful only in the deletion carriers, where a ~1400 bp  deletion-specific band appeared which was then used for determination of the breakpoint by direct sequencing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Téglalap 26"/>
          <p:cNvGrpSpPr/>
          <p:nvPr/>
        </p:nvGrpSpPr>
        <p:grpSpPr>
          <a:xfrm>
            <a:off x="426960" y="781200"/>
            <a:ext cx="480960" cy="334800"/>
            <a:chOff x="426960" y="781200"/>
            <a:chExt cx="480960" cy="334800"/>
          </a:xfrm>
        </p:grpSpPr>
        <p:pic>
          <p:nvPicPr>
            <p:cNvPr id="65" name="Téglalap 26" descr=""/>
            <p:cNvPicPr/>
            <p:nvPr/>
          </p:nvPicPr>
          <p:blipFill>
            <a:blip r:embed="rId2"/>
            <a:stretch/>
          </p:blipFill>
          <p:spPr>
            <a:xfrm>
              <a:off x="426960" y="781200"/>
              <a:ext cx="480960" cy="33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"/>
            <p:cNvSpPr/>
            <p:nvPr/>
          </p:nvSpPr>
          <p:spPr>
            <a:xfrm>
              <a:off x="487440" y="816120"/>
              <a:ext cx="363600" cy="22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Téglalap 28"/>
          <p:cNvGrpSpPr/>
          <p:nvPr/>
        </p:nvGrpSpPr>
        <p:grpSpPr>
          <a:xfrm>
            <a:off x="725400" y="603360"/>
            <a:ext cx="182520" cy="682560"/>
            <a:chOff x="725400" y="603360"/>
            <a:chExt cx="182520" cy="682560"/>
          </a:xfrm>
        </p:grpSpPr>
        <p:pic>
          <p:nvPicPr>
            <p:cNvPr id="68" name="Téglalap 28" descr=""/>
            <p:cNvPicPr/>
            <p:nvPr/>
          </p:nvPicPr>
          <p:blipFill>
            <a:blip r:embed="rId3"/>
            <a:stretch/>
          </p:blipFill>
          <p:spPr>
            <a:xfrm>
              <a:off x="725400" y="603360"/>
              <a:ext cx="182520" cy="68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"/>
            <p:cNvSpPr/>
            <p:nvPr/>
          </p:nvSpPr>
          <p:spPr>
            <a:xfrm>
              <a:off x="785880" y="642960"/>
              <a:ext cx="6804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Téglalap 29"/>
          <p:cNvGrpSpPr/>
          <p:nvPr/>
        </p:nvGrpSpPr>
        <p:grpSpPr>
          <a:xfrm>
            <a:off x="3713040" y="603360"/>
            <a:ext cx="157320" cy="682560"/>
            <a:chOff x="3713040" y="603360"/>
            <a:chExt cx="157320" cy="682560"/>
          </a:xfrm>
        </p:grpSpPr>
        <p:pic>
          <p:nvPicPr>
            <p:cNvPr id="71" name="Téglalap 29" descr=""/>
            <p:cNvPicPr/>
            <p:nvPr/>
          </p:nvPicPr>
          <p:blipFill>
            <a:blip r:embed="rId4"/>
            <a:stretch/>
          </p:blipFill>
          <p:spPr>
            <a:xfrm>
              <a:off x="3713040" y="603360"/>
              <a:ext cx="157320" cy="68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"/>
            <p:cNvSpPr/>
            <p:nvPr/>
          </p:nvSpPr>
          <p:spPr>
            <a:xfrm>
              <a:off x="3772080" y="642960"/>
              <a:ext cx="4572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" name="Téglalap 30"/>
          <p:cNvGrpSpPr/>
          <p:nvPr/>
        </p:nvGrpSpPr>
        <p:grpSpPr>
          <a:xfrm>
            <a:off x="3949560" y="603360"/>
            <a:ext cx="165240" cy="682560"/>
            <a:chOff x="3949560" y="603360"/>
            <a:chExt cx="165240" cy="682560"/>
          </a:xfrm>
        </p:grpSpPr>
        <p:pic>
          <p:nvPicPr>
            <p:cNvPr id="74" name="Téglalap 30" descr=""/>
            <p:cNvPicPr/>
            <p:nvPr/>
          </p:nvPicPr>
          <p:blipFill>
            <a:blip r:embed="rId5"/>
            <a:stretch/>
          </p:blipFill>
          <p:spPr>
            <a:xfrm>
              <a:off x="3949560" y="603360"/>
              <a:ext cx="165240" cy="68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"/>
            <p:cNvSpPr/>
            <p:nvPr/>
          </p:nvSpPr>
          <p:spPr>
            <a:xfrm>
              <a:off x="4013280" y="642960"/>
              <a:ext cx="460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" name="Téglalap 31"/>
          <p:cNvGrpSpPr/>
          <p:nvPr/>
        </p:nvGrpSpPr>
        <p:grpSpPr>
          <a:xfrm>
            <a:off x="4224240" y="603360"/>
            <a:ext cx="165240" cy="682560"/>
            <a:chOff x="4224240" y="603360"/>
            <a:chExt cx="165240" cy="682560"/>
          </a:xfrm>
        </p:grpSpPr>
        <p:pic>
          <p:nvPicPr>
            <p:cNvPr id="77" name="Téglalap 31" descr=""/>
            <p:cNvPicPr/>
            <p:nvPr/>
          </p:nvPicPr>
          <p:blipFill>
            <a:blip r:embed="rId6"/>
            <a:stretch/>
          </p:blipFill>
          <p:spPr>
            <a:xfrm>
              <a:off x="4224240" y="603360"/>
              <a:ext cx="165240" cy="68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"/>
            <p:cNvSpPr/>
            <p:nvPr/>
          </p:nvSpPr>
          <p:spPr>
            <a:xfrm>
              <a:off x="4287960" y="642960"/>
              <a:ext cx="442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" name="Téglalap 32"/>
          <p:cNvGrpSpPr/>
          <p:nvPr/>
        </p:nvGrpSpPr>
        <p:grpSpPr>
          <a:xfrm>
            <a:off x="4286160" y="603360"/>
            <a:ext cx="163440" cy="682560"/>
            <a:chOff x="4286160" y="603360"/>
            <a:chExt cx="163440" cy="682560"/>
          </a:xfrm>
        </p:grpSpPr>
        <p:pic>
          <p:nvPicPr>
            <p:cNvPr id="80" name="Téglalap 32" descr=""/>
            <p:cNvPicPr/>
            <p:nvPr/>
          </p:nvPicPr>
          <p:blipFill>
            <a:blip r:embed="rId7"/>
            <a:stretch/>
          </p:blipFill>
          <p:spPr>
            <a:xfrm>
              <a:off x="4286160" y="603360"/>
              <a:ext cx="163440" cy="68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"/>
            <p:cNvSpPr/>
            <p:nvPr/>
          </p:nvSpPr>
          <p:spPr>
            <a:xfrm>
              <a:off x="4348080" y="642960"/>
              <a:ext cx="460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Téglalap 33"/>
          <p:cNvGrpSpPr/>
          <p:nvPr/>
        </p:nvGrpSpPr>
        <p:grpSpPr>
          <a:xfrm>
            <a:off x="4443480" y="603360"/>
            <a:ext cx="158760" cy="682560"/>
            <a:chOff x="4443480" y="603360"/>
            <a:chExt cx="158760" cy="682560"/>
          </a:xfrm>
        </p:grpSpPr>
        <p:pic>
          <p:nvPicPr>
            <p:cNvPr id="83" name="Téglalap 33" descr=""/>
            <p:cNvPicPr/>
            <p:nvPr/>
          </p:nvPicPr>
          <p:blipFill>
            <a:blip r:embed="rId8"/>
            <a:stretch/>
          </p:blipFill>
          <p:spPr>
            <a:xfrm>
              <a:off x="4443480" y="603360"/>
              <a:ext cx="158760" cy="68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"/>
            <p:cNvSpPr/>
            <p:nvPr/>
          </p:nvSpPr>
          <p:spPr>
            <a:xfrm>
              <a:off x="4503600" y="642960"/>
              <a:ext cx="460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" name="Téglalap 34"/>
          <p:cNvGrpSpPr/>
          <p:nvPr/>
        </p:nvGrpSpPr>
        <p:grpSpPr>
          <a:xfrm>
            <a:off x="4627440" y="603360"/>
            <a:ext cx="157320" cy="682560"/>
            <a:chOff x="4627440" y="603360"/>
            <a:chExt cx="157320" cy="682560"/>
          </a:xfrm>
        </p:grpSpPr>
        <p:pic>
          <p:nvPicPr>
            <p:cNvPr id="86" name="Téglalap 34" descr=""/>
            <p:cNvPicPr/>
            <p:nvPr/>
          </p:nvPicPr>
          <p:blipFill>
            <a:blip r:embed="rId9"/>
            <a:stretch/>
          </p:blipFill>
          <p:spPr>
            <a:xfrm>
              <a:off x="4627440" y="603360"/>
              <a:ext cx="157320" cy="68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"/>
            <p:cNvSpPr/>
            <p:nvPr/>
          </p:nvSpPr>
          <p:spPr>
            <a:xfrm>
              <a:off x="4687920" y="642960"/>
              <a:ext cx="442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Téglalap 36"/>
          <p:cNvGrpSpPr/>
          <p:nvPr/>
        </p:nvGrpSpPr>
        <p:grpSpPr>
          <a:xfrm>
            <a:off x="6114960" y="781200"/>
            <a:ext cx="341280" cy="334800"/>
            <a:chOff x="6114960" y="781200"/>
            <a:chExt cx="341280" cy="334800"/>
          </a:xfrm>
        </p:grpSpPr>
        <p:pic>
          <p:nvPicPr>
            <p:cNvPr id="89" name="Téglalap 36" descr=""/>
            <p:cNvPicPr/>
            <p:nvPr/>
          </p:nvPicPr>
          <p:blipFill>
            <a:blip r:embed="rId10"/>
            <a:stretch/>
          </p:blipFill>
          <p:spPr>
            <a:xfrm>
              <a:off x="6114960" y="781200"/>
              <a:ext cx="341280" cy="33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0" name=""/>
            <p:cNvSpPr/>
            <p:nvPr/>
          </p:nvSpPr>
          <p:spPr>
            <a:xfrm>
              <a:off x="6175440" y="816120"/>
              <a:ext cx="223920" cy="22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" name="Téglalap 37"/>
          <p:cNvGrpSpPr/>
          <p:nvPr/>
        </p:nvGrpSpPr>
        <p:grpSpPr>
          <a:xfrm>
            <a:off x="4913280" y="603360"/>
            <a:ext cx="171360" cy="682560"/>
            <a:chOff x="4913280" y="603360"/>
            <a:chExt cx="171360" cy="682560"/>
          </a:xfrm>
        </p:grpSpPr>
        <p:pic>
          <p:nvPicPr>
            <p:cNvPr id="92" name="Téglalap 37" descr=""/>
            <p:cNvPicPr/>
            <p:nvPr/>
          </p:nvPicPr>
          <p:blipFill>
            <a:blip r:embed="rId11"/>
            <a:stretch/>
          </p:blipFill>
          <p:spPr>
            <a:xfrm>
              <a:off x="4913280" y="603360"/>
              <a:ext cx="171360" cy="68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"/>
            <p:cNvSpPr/>
            <p:nvPr/>
          </p:nvSpPr>
          <p:spPr>
            <a:xfrm>
              <a:off x="4975200" y="642960"/>
              <a:ext cx="5076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4" name="Téglalap 38"/>
          <p:cNvGrpSpPr/>
          <p:nvPr/>
        </p:nvGrpSpPr>
        <p:grpSpPr>
          <a:xfrm>
            <a:off x="5827680" y="781200"/>
            <a:ext cx="182520" cy="334800"/>
            <a:chOff x="5827680" y="781200"/>
            <a:chExt cx="182520" cy="334800"/>
          </a:xfrm>
        </p:grpSpPr>
        <p:pic>
          <p:nvPicPr>
            <p:cNvPr id="95" name="Téglalap 38" descr=""/>
            <p:cNvPicPr/>
            <p:nvPr/>
          </p:nvPicPr>
          <p:blipFill>
            <a:blip r:embed="rId12"/>
            <a:stretch/>
          </p:blipFill>
          <p:spPr>
            <a:xfrm>
              <a:off x="5827680" y="781200"/>
              <a:ext cx="182520" cy="33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"/>
            <p:cNvSpPr/>
            <p:nvPr/>
          </p:nvSpPr>
          <p:spPr>
            <a:xfrm>
              <a:off x="5888160" y="816120"/>
              <a:ext cx="68040" cy="22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7" name="Téglalap 39"/>
          <p:cNvGrpSpPr/>
          <p:nvPr/>
        </p:nvGrpSpPr>
        <p:grpSpPr>
          <a:xfrm>
            <a:off x="5821200" y="603360"/>
            <a:ext cx="171720" cy="682560"/>
            <a:chOff x="5821200" y="603360"/>
            <a:chExt cx="171720" cy="682560"/>
          </a:xfrm>
        </p:grpSpPr>
        <p:pic>
          <p:nvPicPr>
            <p:cNvPr id="98" name="Téglalap 39" descr=""/>
            <p:cNvPicPr/>
            <p:nvPr/>
          </p:nvPicPr>
          <p:blipFill>
            <a:blip r:embed="rId13"/>
            <a:stretch/>
          </p:blipFill>
          <p:spPr>
            <a:xfrm>
              <a:off x="5821200" y="603360"/>
              <a:ext cx="171720" cy="68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"/>
            <p:cNvSpPr/>
            <p:nvPr/>
          </p:nvSpPr>
          <p:spPr>
            <a:xfrm>
              <a:off x="5884920" y="642960"/>
              <a:ext cx="5076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" name="Háromszög 40"/>
          <p:cNvGrpSpPr/>
          <p:nvPr/>
        </p:nvGrpSpPr>
        <p:grpSpPr>
          <a:xfrm>
            <a:off x="1938240" y="762120"/>
            <a:ext cx="182520" cy="371520"/>
            <a:chOff x="1938240" y="762120"/>
            <a:chExt cx="182520" cy="371520"/>
          </a:xfrm>
        </p:grpSpPr>
        <p:pic>
          <p:nvPicPr>
            <p:cNvPr id="101" name="Háromszög 40" descr=""/>
            <p:cNvPicPr/>
            <p:nvPr/>
          </p:nvPicPr>
          <p:blipFill>
            <a:blip r:embed="rId14"/>
            <a:stretch/>
          </p:blipFill>
          <p:spPr>
            <a:xfrm>
              <a:off x="1938240" y="762120"/>
              <a:ext cx="182520" cy="371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2" name=""/>
            <p:cNvSpPr/>
            <p:nvPr/>
          </p:nvSpPr>
          <p:spPr>
            <a:xfrm rot="5400000">
              <a:off x="1949760" y="910080"/>
              <a:ext cx="131760" cy="3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Háromszög 41"/>
          <p:cNvGrpSpPr/>
          <p:nvPr/>
        </p:nvGrpSpPr>
        <p:grpSpPr>
          <a:xfrm>
            <a:off x="4065480" y="762120"/>
            <a:ext cx="189000" cy="371520"/>
            <a:chOff x="4065480" y="762120"/>
            <a:chExt cx="189000" cy="371520"/>
          </a:xfrm>
        </p:grpSpPr>
        <p:pic>
          <p:nvPicPr>
            <p:cNvPr id="104" name="Háromszög 41" descr=""/>
            <p:cNvPicPr/>
            <p:nvPr/>
          </p:nvPicPr>
          <p:blipFill>
            <a:blip r:embed="rId15"/>
            <a:stretch/>
          </p:blipFill>
          <p:spPr>
            <a:xfrm>
              <a:off x="4065480" y="762120"/>
              <a:ext cx="189000" cy="371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"/>
            <p:cNvSpPr/>
            <p:nvPr/>
          </p:nvSpPr>
          <p:spPr>
            <a:xfrm rot="16200000">
              <a:off x="4116600" y="910800"/>
              <a:ext cx="129960" cy="3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6" name="Egyenes összekötő 43"/>
          <p:cNvSpPr/>
          <p:nvPr/>
        </p:nvSpPr>
        <p:spPr>
          <a:xfrm>
            <a:off x="987480" y="1285920"/>
            <a:ext cx="2635200" cy="144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Szövegdoboz 22"/>
          <p:cNvSpPr/>
          <p:nvPr/>
        </p:nvSpPr>
        <p:spPr>
          <a:xfrm>
            <a:off x="1630440" y="1252440"/>
            <a:ext cx="78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3T07:40:39Z</dcterms:created>
  <dc:creator>molbio</dc:creator>
  <dc:description/>
  <dc:language>en-US</dc:language>
  <cp:lastModifiedBy>molbio</cp:lastModifiedBy>
  <dcterms:modified xsi:type="dcterms:W3CDTF">2010-10-22T06:07:25Z</dcterms:modified>
  <cp:revision>34</cp:revision>
  <dc:subject/>
  <dc:title>1. dia</dc:title>
</cp:coreProperties>
</file>